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1746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73CE3A-72F7-4A8C-9726-A8BF86C9D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2CD4F26-0A14-481B-978E-B5FE13B468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DC9984-B128-4B6C-9BAE-C468A73D9B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500A32-2F8D-4DD7-9590-637C09777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D39A14-A844-4083-8D0B-A7DC7501B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349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0D1692-3C7B-4B5B-84A2-832E5BCD0E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58EF272-36F9-41FC-A185-91B62C6EB1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138278-488E-452B-BD6E-634245F1A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A46CE5-3C41-427A-99AD-002768A16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4D7099-D06F-4202-9592-9A8252539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8935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1D056D9-F035-4784-B473-BAADFD4051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2536BB3-7C41-466E-A33B-7F5399C90D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7ED154-B1C5-438D-A707-8E529DD7F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AE3592-1C62-4C3F-84D8-A228E2845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8D91CB-DCB4-4C95-A429-14953EB3B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1136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D5E069-5C0E-47E6-9CCC-6E25B6247F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A229E3A-45D2-4388-90CB-859CFAC7B9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B3AF21-1BF1-4C80-8FD8-D315DCBBC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1FC902-E070-4173-9B9B-23B10CDA1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B64AE7-24EE-4B6C-93E2-DDD30B0FB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7771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787B23-5D77-4226-815D-08DF3C4565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FFD8A91-C5E7-48E0-AB55-1923867BD5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53EDC7-CD6B-41B3-BAAC-06C8B396D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C00CF1D-5FBA-4061-AE7A-C1AF310BF3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53EF43-2B0C-46E8-9E5C-331F1E1B9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4928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255166-3F3A-45CB-A090-21BE4D893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7D61AE-586D-44A5-B49D-3AFDFDA28F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FD92CE8-7334-42C4-80AB-589690FB8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C6C07BC-66F6-411C-B12B-DD3E927E1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612CC4C-7E22-4F3A-9AE1-C8F903C68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AAA521B-054A-4C5D-97BB-10917D214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3277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B8F604-99E7-4F51-A5B6-1D385780F9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CE49222-04E5-42FE-B700-F268D904F3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CAD9B15-BE43-4071-BDFE-38C0BC18F9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5CEFB1F-B954-4CAD-BB40-73EC061E52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66305BB-A8B9-4ECD-83A8-A00A5262AC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B7343BC-633E-4DA6-A146-816C746AE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90EC827-A8BB-4952-80B3-F53A38013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3D3E02F-5DEE-4AEE-B14D-DF5B94016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2694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DFBA5A-09FE-4865-9AD5-630A35314A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67A66D2-65E4-4990-B8B1-AAD7AC40D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30DCB9D-D441-4DF8-AA66-F76C39796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94D5658-8EF0-44F2-9BC7-EAB340469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365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8EE2776-DA5E-4007-94F0-867617BFB1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FB3E863-E426-4BB1-BAC9-5C558EAD1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F7BC174-210C-4BF8-ABB3-A091793AC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6999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D9BF65-9B3E-4E4D-BE00-804D33785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039D4D7-5060-4141-89B5-B17CA8012D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4210B24-6B8B-4FF5-B539-037AB61835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2B09DD2-13B3-4C5D-BEB0-4A2C5F37E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AA4062A-FA4F-4CD4-B1C3-86082F320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81FD7F3-B285-48B7-B647-1E3F372C2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1505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5E6B61-B696-49F7-98D7-9D5C1302BE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47310D9-051B-443F-B642-817AAF4557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996B1EF-4B7A-496B-B200-4FE4D79AAD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A854965-689C-4B65-9E28-A59EF674A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86D82BC-421D-4C69-AE58-E3DBD4A83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C373B3-3F1B-4AB9-8CC9-E2503C8DD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6354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0523163-065B-4BDC-BE20-6B211E996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8236DA5-2A0C-47F7-8674-D8EE553B22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3ABFEE-D054-4AAD-9195-0428570413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6DD76-BD15-4CF3-86B7-D737CF20E6CD}" type="datetimeFigureOut">
              <a:rPr lang="zh-CN" altLang="en-US" smtClean="0"/>
              <a:t>2019/5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631B98-FB58-43CC-BAF0-295F5255EE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C5CBB6-3C8C-4516-89E1-375EFA939E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C55A3-3688-48BD-99B6-699C412BA8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2835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494881D-7E63-4E0B-AAB6-D5D52729B182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164" y="777036"/>
            <a:ext cx="8215266" cy="51250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68C45691-017F-4127-95A6-2AA7A333195A}"/>
              </a:ext>
            </a:extLst>
          </p:cNvPr>
          <p:cNvSpPr/>
          <p:nvPr/>
        </p:nvSpPr>
        <p:spPr>
          <a:xfrm>
            <a:off x="139485" y="0"/>
            <a:ext cx="800857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266700"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1. The inclusion and exclusion flowchart of patients in </a:t>
            </a:r>
            <a:r>
              <a:rPr lang="en-US" altLang="zh-CN" b="1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is study.</a:t>
            </a:r>
            <a:endParaRPr lang="zh-CN" altLang="zh-CN" kern="100" dirty="0">
              <a:latin typeface="Cambria" panose="020405030504060302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45846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99B6878-B66E-4228-B3CB-27E669D039CA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0910" y="833153"/>
            <a:ext cx="6534165" cy="5794151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97606F2B-776D-4410-AD89-380DF9DFE353}"/>
              </a:ext>
            </a:extLst>
          </p:cNvPr>
          <p:cNvSpPr/>
          <p:nvPr/>
        </p:nvSpPr>
        <p:spPr>
          <a:xfrm>
            <a:off x="198581" y="201718"/>
            <a:ext cx="6322291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ig. S2. Testing the robustness of radiomic features.</a:t>
            </a:r>
            <a:endParaRPr lang="zh-CN" altLang="zh-CN" sz="16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Verdana" panose="020B060403050404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9087FBA4-381B-48F5-8BF8-AD637502A360}"/>
              </a:ext>
            </a:extLst>
          </p:cNvPr>
          <p:cNvSpPr/>
          <p:nvPr/>
        </p:nvSpPr>
        <p:spPr>
          <a:xfrm>
            <a:off x="309417" y="5378516"/>
            <a:ext cx="876530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br>
              <a:rPr lang="en-US" altLang="zh-CN" kern="100" dirty="0">
                <a:latin typeface="Times New Roman" panose="02020603050405020304" pitchFamily="18" charset="0"/>
              </a:rPr>
            </a:b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274083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4C067AF-52F7-4847-B243-950645BD13F7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473" y="1457692"/>
            <a:ext cx="8236367" cy="464672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1084126A-7645-4D62-A413-6CC5EC17BDF5}"/>
              </a:ext>
            </a:extLst>
          </p:cNvPr>
          <p:cNvSpPr/>
          <p:nvPr/>
        </p:nvSpPr>
        <p:spPr>
          <a:xfrm>
            <a:off x="217098" y="0"/>
            <a:ext cx="8428138" cy="11159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ig. S3. Inverse probability of treatment weighting (IPTW) in patients in the liver resection and TACE groups. </a:t>
            </a:r>
            <a:endParaRPr lang="zh-CN" altLang="zh-CN" sz="16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67354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DC1EDCB2-2466-4617-852D-DC15C85887F7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9818" y="777348"/>
            <a:ext cx="7278254" cy="583173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EE4EE05C-6390-4531-83F3-BBF1912AFA89}"/>
              </a:ext>
            </a:extLst>
          </p:cNvPr>
          <p:cNvSpPr/>
          <p:nvPr/>
        </p:nvSpPr>
        <p:spPr>
          <a:xfrm>
            <a:off x="300181" y="215399"/>
            <a:ext cx="7947891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ig. S4. AUC comparison between Model</a:t>
            </a:r>
            <a:r>
              <a:rPr lang="en-US" altLang="zh-CN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RR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and Model</a:t>
            </a:r>
            <a:r>
              <a:rPr lang="en-US" altLang="zh-CN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original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.</a:t>
            </a:r>
            <a:endParaRPr lang="zh-CN" altLang="zh-CN" dirty="0">
              <a:solidFill>
                <a:srgbClr val="000000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0833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EA66E8C-ADD9-4705-9068-488475A92751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3803" y="977655"/>
            <a:ext cx="5316394" cy="5192236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C40505B3-4D5B-40E7-85AA-FE92F56BF948}"/>
              </a:ext>
            </a:extLst>
          </p:cNvPr>
          <p:cNvSpPr/>
          <p:nvPr/>
        </p:nvSpPr>
        <p:spPr>
          <a:xfrm>
            <a:off x="258619" y="77268"/>
            <a:ext cx="7319818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ig. S5. Calibration comparison between Model</a:t>
            </a:r>
            <a:r>
              <a:rPr lang="en-US" altLang="zh-CN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RR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and Model</a:t>
            </a:r>
            <a:r>
              <a:rPr lang="en-US" altLang="zh-CN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original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.</a:t>
            </a:r>
            <a:endParaRPr lang="zh-CN" altLang="zh-CN" dirty="0">
              <a:solidFill>
                <a:srgbClr val="000000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02201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AB58AFE-5A1D-4F69-A97B-7FFD6AC522FC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8117" y="662522"/>
            <a:ext cx="6632028" cy="607304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627E4887-FC50-49E4-9ADB-A66ED8504285}"/>
              </a:ext>
            </a:extLst>
          </p:cNvPr>
          <p:cNvSpPr/>
          <p:nvPr/>
        </p:nvSpPr>
        <p:spPr>
          <a:xfrm>
            <a:off x="198581" y="100573"/>
            <a:ext cx="8409709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16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ig. S6. 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aplan-Meier analysis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for PFS in patients without extrahepatic metastasis. </a:t>
            </a:r>
            <a:endParaRPr lang="zh-CN" altLang="zh-CN" sz="16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2354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84</Words>
  <Application>Microsoft Office PowerPoint</Application>
  <PresentationFormat>全屏显示(4:3)</PresentationFormat>
  <Paragraphs>7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等线 Light</vt:lpstr>
      <vt:lpstr>Arial</vt:lpstr>
      <vt:lpstr>Cambria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ryan</dc:creator>
  <cp:lastModifiedBy>Bryan</cp:lastModifiedBy>
  <cp:revision>10</cp:revision>
  <dcterms:created xsi:type="dcterms:W3CDTF">2019-02-26T01:39:22Z</dcterms:created>
  <dcterms:modified xsi:type="dcterms:W3CDTF">2019-05-22T14:29:38Z</dcterms:modified>
</cp:coreProperties>
</file>